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28" d="100"/>
          <a:sy n="128" d="100"/>
        </p:scale>
        <p:origin x="-114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661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4511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8019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6500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0470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5851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0336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4251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955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2473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1811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7E25F-EA8B-4F59-B239-9DD2D63A35A1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6AD7D-F82B-4B52-892E-0215A63FC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1359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/>
          <a:srcRect t="6887" b="10383"/>
          <a:stretch/>
        </p:blipFill>
        <p:spPr>
          <a:xfrm>
            <a:off x="5549613" y="2636912"/>
            <a:ext cx="1747520" cy="1508760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 rot="16200000">
            <a:off x="4825377" y="3229123"/>
            <a:ext cx="1384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5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labelled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6138638" y="4221088"/>
            <a:ext cx="7653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3624725" y="3193546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cap="small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eptor</a:t>
            </a:r>
            <a:r>
              <a:rPr lang="fr-FR" sz="1000" b="1" cap="smal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cap="small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fr-FR" sz="1000" b="1" cap="smal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3"/>
          <a:srcRect t="6887" b="10383"/>
          <a:stretch/>
        </p:blipFill>
        <p:spPr>
          <a:xfrm>
            <a:off x="5549613" y="787919"/>
            <a:ext cx="1747520" cy="1508760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>
            <a:off x="6138638" y="2390691"/>
            <a:ext cx="7653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3696733" y="1298479"/>
            <a:ext cx="10801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cap="small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fr-FR" sz="1000" b="1" cap="smal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cap="small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fr-FR" sz="1000" b="1" cap="smal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2342467" y="2308810"/>
            <a:ext cx="12241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cap="small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fr-FR" sz="1000" b="1" cap="smal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ogocytosis</a:t>
            </a:r>
            <a:endParaRPr lang="fr-FR" sz="1000" b="1" cap="smal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2342467" y="5373216"/>
            <a:ext cx="12241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cap="smal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Trogocytosis</a:t>
            </a:r>
            <a:endParaRPr lang="fr-FR" sz="1000" b="1" cap="smal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4"/>
          <a:srcRect t="7399" b="10602"/>
          <a:stretch/>
        </p:blipFill>
        <p:spPr>
          <a:xfrm>
            <a:off x="5549613" y="4737580"/>
            <a:ext cx="1747520" cy="1495427"/>
          </a:xfrm>
          <a:prstGeom prst="rect">
            <a:avLst/>
          </a:prstGeom>
        </p:spPr>
      </p:pic>
      <p:sp>
        <p:nvSpPr>
          <p:cNvPr id="17" name="ZoneTexte 16"/>
          <p:cNvSpPr txBox="1"/>
          <p:nvPr/>
        </p:nvSpPr>
        <p:spPr>
          <a:xfrm rot="16200000">
            <a:off x="4825376" y="1406064"/>
            <a:ext cx="1384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5 non-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labelled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ZoneTexte 17"/>
          <p:cNvSpPr txBox="1"/>
          <p:nvPr/>
        </p:nvSpPr>
        <p:spPr>
          <a:xfrm rot="16200000">
            <a:off x="4825376" y="5349732"/>
            <a:ext cx="1384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5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6138638" y="6309320"/>
            <a:ext cx="7653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7" name="Groupe 26"/>
          <p:cNvGrpSpPr/>
          <p:nvPr/>
        </p:nvGrpSpPr>
        <p:grpSpPr>
          <a:xfrm>
            <a:off x="5640949" y="787920"/>
            <a:ext cx="1656184" cy="1585703"/>
            <a:chOff x="3563888" y="787920"/>
            <a:chExt cx="1656184" cy="1585703"/>
          </a:xfrm>
        </p:grpSpPr>
        <p:cxnSp>
          <p:nvCxnSpPr>
            <p:cNvPr id="21" name="Connecteur droit avec flèche 20"/>
            <p:cNvCxnSpPr/>
            <p:nvPr/>
          </p:nvCxnSpPr>
          <p:spPr>
            <a:xfrm>
              <a:off x="3563888" y="2373623"/>
              <a:ext cx="165618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avec flèche 21"/>
            <p:cNvCxnSpPr/>
            <p:nvPr/>
          </p:nvCxnSpPr>
          <p:spPr>
            <a:xfrm flipV="1">
              <a:off x="3563888" y="787920"/>
              <a:ext cx="0" cy="158570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oupe 27"/>
          <p:cNvGrpSpPr/>
          <p:nvPr/>
        </p:nvGrpSpPr>
        <p:grpSpPr>
          <a:xfrm>
            <a:off x="5640949" y="2636912"/>
            <a:ext cx="1656184" cy="1585703"/>
            <a:chOff x="3563888" y="787920"/>
            <a:chExt cx="1656184" cy="1585703"/>
          </a:xfrm>
        </p:grpSpPr>
        <p:cxnSp>
          <p:nvCxnSpPr>
            <p:cNvPr id="29" name="Connecteur droit avec flèche 28"/>
            <p:cNvCxnSpPr/>
            <p:nvPr/>
          </p:nvCxnSpPr>
          <p:spPr>
            <a:xfrm>
              <a:off x="3563888" y="2373623"/>
              <a:ext cx="165618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eur droit avec flèche 29"/>
            <p:cNvCxnSpPr/>
            <p:nvPr/>
          </p:nvCxnSpPr>
          <p:spPr>
            <a:xfrm flipV="1">
              <a:off x="3563888" y="787920"/>
              <a:ext cx="0" cy="158570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oupe 30"/>
          <p:cNvGrpSpPr/>
          <p:nvPr/>
        </p:nvGrpSpPr>
        <p:grpSpPr>
          <a:xfrm>
            <a:off x="5640949" y="4725144"/>
            <a:ext cx="1656184" cy="1585703"/>
            <a:chOff x="3563888" y="787920"/>
            <a:chExt cx="1656184" cy="1585703"/>
          </a:xfrm>
        </p:grpSpPr>
        <p:cxnSp>
          <p:nvCxnSpPr>
            <p:cNvPr id="32" name="Connecteur droit avec flèche 31"/>
            <p:cNvCxnSpPr/>
            <p:nvPr/>
          </p:nvCxnSpPr>
          <p:spPr>
            <a:xfrm>
              <a:off x="3563888" y="2373623"/>
              <a:ext cx="165618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cteur droit avec flèche 32"/>
            <p:cNvCxnSpPr/>
            <p:nvPr/>
          </p:nvCxnSpPr>
          <p:spPr>
            <a:xfrm flipV="1">
              <a:off x="3563888" y="787920"/>
              <a:ext cx="0" cy="158570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Rectangle 33"/>
          <p:cNvSpPr/>
          <p:nvPr/>
        </p:nvSpPr>
        <p:spPr>
          <a:xfrm>
            <a:off x="3624726" y="692696"/>
            <a:ext cx="3827594" cy="377461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5" name="Rectangle 34"/>
          <p:cNvSpPr/>
          <p:nvPr/>
        </p:nvSpPr>
        <p:spPr>
          <a:xfrm>
            <a:off x="3624725" y="4653135"/>
            <a:ext cx="3827594" cy="190240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6" name="ZoneTexte 35"/>
          <p:cNvSpPr txBox="1"/>
          <p:nvPr/>
        </p:nvSpPr>
        <p:spPr>
          <a:xfrm>
            <a:off x="0" y="0"/>
            <a:ext cx="1979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cap="small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200" b="1" cap="smal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endParaRPr lang="fr-FR" sz="1200" b="1" cap="smal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88597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9</Words>
  <Application>Microsoft Office PowerPoint</Application>
  <PresentationFormat>Affichage à l'écran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ommissariat à l'Energie Atomiqu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UMARTIN Julien</dc:creator>
  <cp:lastModifiedBy>LE MAOULT  joël 202104</cp:lastModifiedBy>
  <cp:revision>10</cp:revision>
  <dcterms:created xsi:type="dcterms:W3CDTF">2014-06-20T13:07:17Z</dcterms:created>
  <dcterms:modified xsi:type="dcterms:W3CDTF">2014-06-23T13:43:35Z</dcterms:modified>
</cp:coreProperties>
</file>